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56" r:id="rId3"/>
    <p:sldId id="262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84" y="103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5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5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5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5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5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5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5/2025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5/2025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5/2025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5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5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8/05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hyperlink" Target="https://guyabel.com/post/global-migrant-chord-diagrams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://creativecommons.org/licenses/by/4.0/" TargetMode="Externa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://creativecommons.org/licenses/by/4.0/" TargetMode="Externa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7504" y="5560476"/>
            <a:ext cx="7992888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Bennet et al (2025) Diabetologia DOI 10.1007/s00125-025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465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9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Reproduced from Abel (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s://guyabel.com/post/global-migrant-chord-diagrams/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 with permission</a:t>
            </a: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The global flow of migration in 1990 and 2020</a:t>
            </a:r>
            <a:endParaRPr lang="en-GB" sz="1800" b="1"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9FEAB76B-0019-E76E-A933-AC9B83A5F73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1520" y="1278073"/>
            <a:ext cx="4248000" cy="4160353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A2139E20-BF92-F5BA-3D72-7AA1302AFEF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44008" y="1297524"/>
            <a:ext cx="4248000" cy="4147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79512" y="5661248"/>
            <a:ext cx="7128792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60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+mn-ea"/>
                <a:cs typeface="+mn-cs"/>
              </a:rPr>
              <a:t>Bennet et al (2025) Diabetologia DOI 10.1007/s00125-025-</a:t>
            </a:r>
            <a:r>
              <a:rPr lang="en-GB" dirty="0">
                <a:solidFill>
                  <a:prstClr val="black"/>
                </a:solidFill>
              </a:rPr>
              <a:t>06465-9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+mn-ea"/>
                <a:cs typeface="+mn-cs"/>
              </a:rPr>
              <a:t> </a:t>
            </a:r>
          </a:p>
          <a:p>
            <a:r>
              <a:rPr lang="en-GB" sz="1200" dirty="0"/>
              <a:t>Adapted from Agyemang et al (DOI </a:t>
            </a:r>
            <a:r>
              <a:rPr lang="en-US" sz="1200" kern="0" dirty="0">
                <a:effectLst/>
                <a:ea typeface="Times New Roman" panose="02020603050405020304" pitchFamily="18" charset="0"/>
              </a:rPr>
              <a:t>10.1007/s00125-021-05586-1</a:t>
            </a:r>
            <a:r>
              <a:rPr lang="en-GB" sz="1200" dirty="0"/>
              <a:t>) </a:t>
            </a:r>
            <a:r>
              <a:rPr lang="en-GB" sz="1200" kern="0" dirty="0">
                <a:effectLst/>
                <a:ea typeface="Times New Roman" panose="02020603050405020304" pitchFamily="18" charset="0"/>
              </a:rPr>
              <a:t>under the terms of</a:t>
            </a:r>
            <a:r>
              <a:rPr lang="en-US" sz="1200" kern="0" dirty="0">
                <a:effectLst/>
                <a:ea typeface="Times New Roman" panose="02020603050405020304" pitchFamily="18" charset="0"/>
              </a:rPr>
              <a:t> the CC BY 4.0 Attribution License (</a:t>
            </a:r>
            <a:r>
              <a:rPr lang="en-US" sz="1200" u="sng" kern="0" dirty="0">
                <a:solidFill>
                  <a:srgbClr val="0000FF"/>
                </a:solidFill>
                <a:effectLst/>
                <a:ea typeface="Times New Roman" panose="02020603050405020304" pitchFamily="18" charset="0"/>
                <a:hlinkClick r:id="rId2"/>
              </a:rPr>
              <a:t>http://creativecommons.org/licenses/by/4.0/</a:t>
            </a:r>
            <a:r>
              <a:rPr lang="en-US" sz="1200" kern="0" dirty="0">
                <a:effectLst/>
                <a:ea typeface="Times New Roman" panose="02020603050405020304" pitchFamily="18" charset="0"/>
              </a:rPr>
              <a:t>)</a:t>
            </a:r>
            <a:endParaRPr lang="en-GB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251520" y="272842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Potential drivers for type 2 diabetes in migrants from low- and middle-income countries living in high-income countries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01E8FF3-0F44-B226-F50A-B25A70E5400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35024" y="1030167"/>
            <a:ext cx="5673953" cy="4797667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07504" y="5733256"/>
            <a:ext cx="648072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pt-BR" dirty="0"/>
              <a:t>Bennet et al (2025) Diabetologia DOI 10.1007</a:t>
            </a:r>
            <a:r>
              <a:rPr lang="pt-BR"/>
              <a:t>/s00125-025-06465-9 </a:t>
            </a:r>
            <a:endParaRPr lang="pt-BR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2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95536" y="332656"/>
            <a:ext cx="820891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Illustration of a culturally sensitive lifestyle intervention addressing social determinants of health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B3C6895E-9C39-6094-451C-44F3F55C2B4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8529" y="1078566"/>
            <a:ext cx="7526943" cy="44386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59605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1</Words>
  <Application>Microsoft Office PowerPoint</Application>
  <PresentationFormat>On-screen Show (4:3)</PresentationFormat>
  <Paragraphs>14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Editorial Office</cp:lastModifiedBy>
  <cp:revision>48</cp:revision>
  <dcterms:created xsi:type="dcterms:W3CDTF">2016-06-15T12:53:43Z</dcterms:created>
  <dcterms:modified xsi:type="dcterms:W3CDTF">2025-05-28T11:46:04Z</dcterms:modified>
</cp:coreProperties>
</file>